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57" r:id="rId4"/>
    <p:sldId id="258" r:id="rId5"/>
    <p:sldId id="262" r:id="rId6"/>
    <p:sldId id="259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990" y="18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96D62F-8493-A052-8758-D965999F047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AB1560C-680F-142E-E45F-64FF215CBF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309554-E7C0-C78F-A3AF-6338990DC7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42AF6-35FA-485E-B14F-D56EFE5F1A80}" type="datetimeFigureOut">
              <a:rPr lang="en-US" smtClean="0"/>
              <a:t>10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523A34-FE6F-4FF1-7EF5-913EC39D30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64FEB0-5F2C-E4CF-6179-546A646C53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9D50E-5D46-4838-868C-8E95E3BB1A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46726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34C1DD-90F5-A1FD-C90B-847B93892F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B023DD4-BC96-2DA6-F78F-0011BB7A4D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7C600F-AE15-7430-916F-603EBDA3FA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42AF6-35FA-485E-B14F-D56EFE5F1A80}" type="datetimeFigureOut">
              <a:rPr lang="en-US" smtClean="0"/>
              <a:t>10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5BCA54-5500-EBEC-3D3B-83C4F6F565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3E32A4-7655-6393-2DFD-7785D32FCD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9D50E-5D46-4838-868C-8E95E3BB1A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69422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0671832-3109-6002-B361-DAEB28224B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C7BDEAB-3505-A88D-A110-6CC8E3D372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53583A-03C3-306D-5E00-BBFCCC422D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42AF6-35FA-485E-B14F-D56EFE5F1A80}" type="datetimeFigureOut">
              <a:rPr lang="en-US" smtClean="0"/>
              <a:t>10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FDC41F-3DE5-31EC-F9D9-05C944AB30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88D118-A09D-83CB-953A-70E02EDA4C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9D50E-5D46-4838-868C-8E95E3BB1A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1672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16A53C-0D89-5E11-1715-6FA47AFDD2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BA57DB-5ADC-75E2-81C9-8873E3F1B9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C44313-D2D4-D7B3-F703-D108FD8442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42AF6-35FA-485E-B14F-D56EFE5F1A80}" type="datetimeFigureOut">
              <a:rPr lang="en-US" smtClean="0"/>
              <a:t>10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DDCDE6-A241-7123-F63F-C7F42D69D6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F5746C-AF29-9452-6799-2E6554A8B9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9D50E-5D46-4838-868C-8E95E3BB1A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8461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F99CC8-2947-91AE-914B-F5F713FD91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BC886D7-A072-0760-130B-792CF7EB0C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DF7300-D513-4AE8-AD58-329C857B97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42AF6-35FA-485E-B14F-D56EFE5F1A80}" type="datetimeFigureOut">
              <a:rPr lang="en-US" smtClean="0"/>
              <a:t>10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D4643B-5579-C08C-CF9A-B8DA89146D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F8EE65-E9CC-51A4-4A68-7D4E80E402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9D50E-5D46-4838-868C-8E95E3BB1A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70901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09E24D-8D4D-B47F-5F6F-D1F38EEE83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C5C391-7717-5352-D4B2-E391BF1683C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61D14E-4ED7-8306-5F89-BCE2D1F93C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D465AE1-A837-61B0-59E7-708B2DABBD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42AF6-35FA-485E-B14F-D56EFE5F1A80}" type="datetimeFigureOut">
              <a:rPr lang="en-US" smtClean="0"/>
              <a:t>10/2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0CBFE0-BC41-24A2-182C-792EC4A08C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F26CBD-1AE5-CA1E-2E5B-14A3FE46C9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9D50E-5D46-4838-868C-8E95E3BB1A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848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0D69F6-3810-FEC9-6850-B220D525D2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9FFA6F-A2B3-9A0E-B54D-3EBCD07ED6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3C3086E-09BA-FA1B-E6E6-C2A4BF117A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213F021-5B2D-0FE8-789B-100BF55EC9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AF16565-8530-414D-1ED1-CFFD78BCCA4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95CED5F-4A79-A402-17CC-62A5A59253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42AF6-35FA-485E-B14F-D56EFE5F1A80}" type="datetimeFigureOut">
              <a:rPr lang="en-US" smtClean="0"/>
              <a:t>10/22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6667C73-02E3-6517-B921-42DDA38A7E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A6AAB42-113F-4A81-6B7E-A9336E06DF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9D50E-5D46-4838-868C-8E95E3BB1A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3579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5F42A1-AB93-E1A2-349E-A554F91DE1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6B856E1-22B2-54F5-3A6E-910270B465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42AF6-35FA-485E-B14F-D56EFE5F1A80}" type="datetimeFigureOut">
              <a:rPr lang="en-US" smtClean="0"/>
              <a:t>10/22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450B8D8-5BC2-F46D-1B3F-8F7A922710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2A892D7-AD77-15E8-FC4D-AAAE7C22AE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9D50E-5D46-4838-868C-8E95E3BB1A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2927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58E1CB6-A6A8-170C-81EC-0109915E6F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42AF6-35FA-485E-B14F-D56EFE5F1A80}" type="datetimeFigureOut">
              <a:rPr lang="en-US" smtClean="0"/>
              <a:t>10/22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79809EA-9E53-73E8-1C16-760D5EB0E4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F82B27D-C023-44F1-3932-DB73123D9B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9D50E-5D46-4838-868C-8E95E3BB1A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76232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2E085A-08C7-8326-8AA0-717EAE8E91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CA91DC-349B-C242-F623-8A6079B4D50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27D5C88-9782-8EA8-6D11-DCF66B6739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CC397B-67B9-3940-4FC5-3E7A558927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42AF6-35FA-485E-B14F-D56EFE5F1A80}" type="datetimeFigureOut">
              <a:rPr lang="en-US" smtClean="0"/>
              <a:t>10/2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16F6BA-3E35-1C70-620E-84FC16E972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D85057D-AED6-0F95-A412-E5DAB9C731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9D50E-5D46-4838-868C-8E95E3BB1A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52892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6F0B67-7E20-894C-3C3D-BA57FB9331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557430E-2EAA-3089-90ED-24EF182F55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BB983A1-6C42-7761-3999-3317C9B8F2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92C040-1427-2791-80F2-FA678D5282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42AF6-35FA-485E-B14F-D56EFE5F1A80}" type="datetimeFigureOut">
              <a:rPr lang="en-US" smtClean="0"/>
              <a:t>10/2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236A31-000E-A9BF-6A95-D9DB2A8541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836231-557B-FAFB-F386-F781C1DBE5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9D50E-5D46-4838-868C-8E95E3BB1A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02011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18C7896-D643-1D34-87A3-BF877AD1CE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222F44-D24C-5B61-AF51-C1497C22B7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61236D-1614-0374-4BB1-839161F3511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F42AF6-35FA-485E-B14F-D56EFE5F1A80}" type="datetimeFigureOut">
              <a:rPr lang="en-US" smtClean="0"/>
              <a:t>10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4DFE48-329C-FD66-8AF4-611EEB7FCEB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227F81-E658-90D5-A0C2-4F55CDD829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09D50E-5D46-4838-868C-8E95E3BB1A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94851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F67703E-D463-25BF-111E-BED16BE545F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6000" y="817433"/>
            <a:ext cx="9000000" cy="4965516"/>
          </a:xfrm>
          <a:prstGeom prst="rect">
            <a:avLst/>
          </a:prstGeom>
          <a:ln>
            <a:noFill/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2ABC7ABE-C256-B4AC-EE89-38B63AAD1D6E}"/>
              </a:ext>
            </a:extLst>
          </p:cNvPr>
          <p:cNvSpPr txBox="1"/>
          <p:nvPr/>
        </p:nvSpPr>
        <p:spPr>
          <a:xfrm>
            <a:off x="0" y="6257925"/>
            <a:ext cx="11824647" cy="6155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tter plot of the KEGG pathways in which the DAMs in R65 vs R85 were significantly enriched. Where, R65 and R85 refer to</a:t>
            </a:r>
          </a:p>
          <a:p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rocessing temperatures of 6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5℃ and 85℃, respectively.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38475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4A54DE1E-970F-5DBF-D23C-1943749026C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6000" y="430701"/>
            <a:ext cx="9000000" cy="5454545"/>
          </a:xfrm>
          <a:prstGeom prst="rect">
            <a:avLst/>
          </a:prstGeom>
          <a:ln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CAD5F2E-C526-028E-9719-2A4BC1176FBA}"/>
              </a:ext>
            </a:extLst>
          </p:cNvPr>
          <p:cNvSpPr txBox="1"/>
          <p:nvPr/>
        </p:nvSpPr>
        <p:spPr>
          <a:xfrm>
            <a:off x="0" y="6257925"/>
            <a:ext cx="1179861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p differentially accumulated metabolites between R85 and R105. Where R85 and R105 indicate the processing temperatures of</a:t>
            </a:r>
          </a:p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5℃ and 105℃, respectively.</a:t>
            </a:r>
          </a:p>
        </p:txBody>
      </p:sp>
    </p:spTree>
    <p:extLst>
      <p:ext uri="{BB962C8B-B14F-4D97-AF65-F5344CB8AC3E}">
        <p14:creationId xmlns:p14="http://schemas.microsoft.com/office/powerpoint/2010/main" val="16693237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9BB85980-28A2-7B3D-A8FA-FE3A92B1829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6000" y="271047"/>
            <a:ext cx="9000000" cy="5487805"/>
          </a:xfrm>
          <a:prstGeom prst="rect">
            <a:avLst/>
          </a:prstGeom>
          <a:ln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42C9188-8008-8634-598D-4AE650A235C4}"/>
              </a:ext>
            </a:extLst>
          </p:cNvPr>
          <p:cNvSpPr txBox="1"/>
          <p:nvPr/>
        </p:nvSpPr>
        <p:spPr>
          <a:xfrm>
            <a:off x="0" y="6257925"/>
            <a:ext cx="1179861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p differentially accumulated metabolites between R85 and R125. Where R85 and R125 indicate the processing temperatures of</a:t>
            </a:r>
          </a:p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5℃ and 125℃, respectively.</a:t>
            </a:r>
          </a:p>
        </p:txBody>
      </p:sp>
    </p:spTree>
    <p:extLst>
      <p:ext uri="{BB962C8B-B14F-4D97-AF65-F5344CB8AC3E}">
        <p14:creationId xmlns:p14="http://schemas.microsoft.com/office/powerpoint/2010/main" val="33319895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51517B3-475C-F4F9-E1DB-9ED7F9A2A40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6000" y="942971"/>
            <a:ext cx="9000000" cy="449999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AB73EA0-096E-F0FF-0731-CA65DE08A245}"/>
              </a:ext>
            </a:extLst>
          </p:cNvPr>
          <p:cNvSpPr txBox="1"/>
          <p:nvPr/>
        </p:nvSpPr>
        <p:spPr>
          <a:xfrm>
            <a:off x="0" y="6257925"/>
            <a:ext cx="11938461" cy="6155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tter plot of the KEGG pathways in which the DAMs in R85 vs R125 were significantly enriched. Where, R85 and R125 refer to</a:t>
            </a:r>
          </a:p>
          <a:p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rocessing temperatures of 8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5℃ and 125℃, respectively.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608717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1325C51-E600-40D3-7DAD-415B9FFDDCE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6638" y="266700"/>
            <a:ext cx="7200000" cy="5625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0F04955-8BA1-2E86-0C9A-E8838240F2F1}"/>
              </a:ext>
            </a:extLst>
          </p:cNvPr>
          <p:cNvSpPr txBox="1"/>
          <p:nvPr/>
        </p:nvSpPr>
        <p:spPr>
          <a:xfrm>
            <a:off x="0" y="6257925"/>
            <a:ext cx="1200379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p differentially accumulated metabolites between R105 and R125. Where R105 and R125 indicate the processing temperatures of</a:t>
            </a:r>
          </a:p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5℃ and 125℃, respectively.</a:t>
            </a:r>
          </a:p>
        </p:txBody>
      </p:sp>
    </p:spTree>
    <p:extLst>
      <p:ext uri="{BB962C8B-B14F-4D97-AF65-F5344CB8AC3E}">
        <p14:creationId xmlns:p14="http://schemas.microsoft.com/office/powerpoint/2010/main" val="158028111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8F9583C-939C-2693-8498-D1DB69055BC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6000" y="1028696"/>
            <a:ext cx="9000000" cy="449999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06F1FF4-8F90-3594-36F6-7D295A246474}"/>
              </a:ext>
            </a:extLst>
          </p:cNvPr>
          <p:cNvSpPr txBox="1"/>
          <p:nvPr/>
        </p:nvSpPr>
        <p:spPr>
          <a:xfrm>
            <a:off x="0" y="6257925"/>
            <a:ext cx="12041053" cy="6155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tter plot of the KEGG pathways in which the DAMs in R105 vs R125 were significantly enriched. Where, R105 and R125 refer to</a:t>
            </a:r>
          </a:p>
          <a:p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rocessing temperatures of 105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5℃ and 125℃, respectively.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22442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207</Words>
  <Application>Microsoft Office PowerPoint</Application>
  <PresentationFormat>Widescreen</PresentationFormat>
  <Paragraphs>12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mjad</dc:creator>
  <cp:lastModifiedBy>Amjad</cp:lastModifiedBy>
  <cp:revision>8</cp:revision>
  <dcterms:created xsi:type="dcterms:W3CDTF">2024-10-22T04:00:30Z</dcterms:created>
  <dcterms:modified xsi:type="dcterms:W3CDTF">2024-10-22T04:25:49Z</dcterms:modified>
</cp:coreProperties>
</file>